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53" d="100"/>
          <a:sy n="53" d="100"/>
        </p:scale>
        <p:origin x="72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221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972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32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17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906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897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817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988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296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328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713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30C28-9D1F-4F50-AEDE-ACD108C7CA3E}" type="datetimeFigureOut">
              <a:rPr kumimoji="1" lang="ja-JP" altLang="en-US" smtClean="0"/>
              <a:t>2023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949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背景パターン&#10;&#10;自動的に生成された説明">
            <a:extLst>
              <a:ext uri="{FF2B5EF4-FFF2-40B4-BE49-F238E27FC236}">
                <a16:creationId xmlns:a16="http://schemas.microsoft.com/office/drawing/2014/main" id="{4069ABBA-19E2-603F-452E-F7749A3AED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981" y="452269"/>
            <a:ext cx="9539225" cy="1129428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B3AE774-9991-23EA-C43B-14249EFA0DBA}"/>
              </a:ext>
            </a:extLst>
          </p:cNvPr>
          <p:cNvSpPr txBox="1"/>
          <p:nvPr/>
        </p:nvSpPr>
        <p:spPr>
          <a:xfrm>
            <a:off x="13636372" y="0"/>
            <a:ext cx="26196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 Fig.2</a:t>
            </a:r>
            <a:endParaRPr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12E3090-AD83-FB4C-5644-A762198BC8C1}"/>
              </a:ext>
            </a:extLst>
          </p:cNvPr>
          <p:cNvSpPr txBox="1"/>
          <p:nvPr/>
        </p:nvSpPr>
        <p:spPr>
          <a:xfrm>
            <a:off x="325044" y="46010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FDD462-2BB0-8EBE-1991-6405674D6267}"/>
              </a:ext>
            </a:extLst>
          </p:cNvPr>
          <p:cNvSpPr txBox="1"/>
          <p:nvPr/>
        </p:nvSpPr>
        <p:spPr>
          <a:xfrm>
            <a:off x="5087883" y="46010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55941CE-DBAD-9848-2C5D-48E8578D3894}"/>
              </a:ext>
            </a:extLst>
          </p:cNvPr>
          <p:cNvSpPr txBox="1"/>
          <p:nvPr/>
        </p:nvSpPr>
        <p:spPr>
          <a:xfrm>
            <a:off x="325044" y="4234857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0EAE54C-ABCC-3AB7-1ACA-2FE372BEDFBE}"/>
              </a:ext>
            </a:extLst>
          </p:cNvPr>
          <p:cNvSpPr txBox="1"/>
          <p:nvPr/>
        </p:nvSpPr>
        <p:spPr>
          <a:xfrm>
            <a:off x="5087883" y="4253166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0D241BD-8CDF-E75D-2F4E-B7ACADBE6E42}"/>
              </a:ext>
            </a:extLst>
          </p:cNvPr>
          <p:cNvSpPr txBox="1"/>
          <p:nvPr/>
        </p:nvSpPr>
        <p:spPr>
          <a:xfrm>
            <a:off x="325044" y="8005956"/>
            <a:ext cx="4587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2E51FE8-9D81-7763-F5E3-37498F2C94F7}"/>
              </a:ext>
            </a:extLst>
          </p:cNvPr>
          <p:cNvSpPr txBox="1"/>
          <p:nvPr/>
        </p:nvSpPr>
        <p:spPr>
          <a:xfrm>
            <a:off x="5099869" y="8038905"/>
            <a:ext cx="43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FFB489A-47A5-678C-A434-3C01934E294C}"/>
              </a:ext>
            </a:extLst>
          </p:cNvPr>
          <p:cNvSpPr txBox="1"/>
          <p:nvPr/>
        </p:nvSpPr>
        <p:spPr>
          <a:xfrm>
            <a:off x="9924228" y="8064324"/>
            <a:ext cx="6190197" cy="36822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</a:t>
            </a:r>
          </a:p>
          <a:p>
            <a:pPr algn="just">
              <a:lnSpc>
                <a:spcPct val="200000"/>
              </a:lnSpc>
            </a:pPr>
            <a:r>
              <a:rPr lang="en-US" altLang="ja-JP" sz="2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E staining of the tumorous tissue-sections of subject #168. (A) endometrial cancer (#11Ca), (B, C) hyperplasia (#11HP, #9HP), and (D, E, F) normal endometrium </a:t>
            </a:r>
            <a:r>
              <a:rPr lang="en-US" altLang="ja-JP" sz="24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#9N, #10N, #12N)</a:t>
            </a:r>
            <a:endParaRPr lang="ja-JP" altLang="ja-JP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4115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5</TotalTime>
  <Words>64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根　希世子</dc:creator>
  <cp:lastModifiedBy>古川　洋一</cp:lastModifiedBy>
  <cp:revision>9</cp:revision>
  <dcterms:created xsi:type="dcterms:W3CDTF">2023-04-13T23:54:44Z</dcterms:created>
  <dcterms:modified xsi:type="dcterms:W3CDTF">2023-10-27T13:37:43Z</dcterms:modified>
</cp:coreProperties>
</file>